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17" r:id="rId1"/>
  </p:sldMasterIdLst>
  <p:notesMasterIdLst>
    <p:notesMasterId r:id="rId10"/>
  </p:notesMasterIdLst>
  <p:sldIdLst>
    <p:sldId id="294" r:id="rId2"/>
    <p:sldId id="295" r:id="rId3"/>
    <p:sldId id="296" r:id="rId4"/>
    <p:sldId id="297" r:id="rId5"/>
    <p:sldId id="298" r:id="rId6"/>
    <p:sldId id="299" r:id="rId7"/>
    <p:sldId id="301" r:id="rId8"/>
    <p:sldId id="300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FF7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83"/>
    <p:restoredTop sz="89617"/>
  </p:normalViewPr>
  <p:slideViewPr>
    <p:cSldViewPr snapToGrid="0" snapToObjects="1">
      <p:cViewPr varScale="1">
        <p:scale>
          <a:sx n="103" d="100"/>
          <a:sy n="103" d="100"/>
        </p:scale>
        <p:origin x="14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550D4F-AF67-C240-830A-CA316B8631C8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E743A4-6B81-164D-B1AA-B82823155C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852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537E7-1B0C-9049-86FF-6A8A83E2E1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AA8307-1FA5-2944-892A-1B2C527142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2354D8-AEEB-5542-B431-B6CDA9E97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744FB9-36A0-9E4C-8D29-AF06472A6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E4E6CD-92E0-ED42-9869-96926BDC6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915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B84F86-17DB-7243-9F8D-4DAD5CA87E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A20105-B462-9D4E-AAD5-3BF95545C2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948F78-F479-1245-B610-1D7F928B2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75B2B9-90A7-A34F-B8B6-02D91D96C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4DCC4-4814-304F-B7D0-394A30757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623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53C328-7E40-2649-B03E-C38813F2AC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2DDAE7-9ABA-AB4A-8A4B-959894016E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91EBB-F4C8-2A4C-9848-6E77002F3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13A823-6B0C-4C45-ADD5-45C7D0A2F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DFA7E-1169-1C46-BB30-829A89DC7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119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CA1FF1-D3A2-1D4A-BBCF-F1BC0F9F5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55C89C-FB69-894C-99D0-84D3C5168A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E1B9B-1100-1948-89D5-C98A2A7FA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679C31-24AB-D941-B3A5-902ACE189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BC269-0D25-1E48-9E32-C10BA74F0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9915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C0AEC-3A03-AF4A-9545-81F515185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86C1A7-4FEF-F44B-A09E-6FDF284989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E6DF22-9EB5-5142-A5D6-911FF1034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A8C096-269E-3A46-A0C9-0678EF58F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2A64D7-9ED6-934F-B9D8-6A23C382E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74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E54B8-DDE5-5041-B2BC-E70209F8A9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EEA44-E66B-C949-B007-4442208430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11281B-A995-BA4C-B77F-78F0C79931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FB9196-F44F-A241-B374-C04F05D42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2D33F1-3BBC-9D41-8F1C-67255657E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0E02A3-2F43-8946-8D64-49FF3B85D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09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A9E73-30EE-9548-A8EB-2680DFF87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42C012-BAEC-B948-A4F4-E7C71AD807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2BDE63-BA78-3445-AFE1-432C7ED6B7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F4E0FF-4E17-C048-880A-4B0E22591D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EF12909-1ADA-2A43-A098-0F3CEAD6A6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79E60D-6BE6-454B-9D29-EF1B6B4C0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3F3083-8159-3746-83A7-66577989B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5262E7-F228-3F45-8F8F-725FE038A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4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FF1E6-C0D8-564A-A068-570DFE5AD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85949F-A66F-5147-8A6A-B4643E3DF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4AE092-3150-DA41-B9ED-E80968F20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98112F-DF0D-0C4C-A395-3F3FB7C91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710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2B9185-8D97-204A-97EF-DF0D23A96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2EA541-B405-3C4B-83D9-C2D785BD4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760CC7-7087-C841-8AA8-4B1A2BB35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12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473A9C-311F-8047-905D-75B47F5894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692A65-ABE7-4E49-A998-C734000EF7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D31395-40F9-BA4B-923F-18CA10EE8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2E01C2-79D4-674F-89CA-1A5179C7F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AA404B-3278-754B-98C5-66CBC1CA0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5051AC-971F-A648-AA99-8EA8DBE3D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50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66A2AF-EDB7-6C4D-9A3A-EBF4097CC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2BF865-D2BC-D543-A076-B85A0C7DD1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D7702B-B8B0-8647-B1F9-813C195F5F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6A1511-60D7-5941-AFC5-B89FE9ADA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98F52-2787-4BA2-BBBC-9395E9F86D50}" type="datetimeFigureOut">
              <a:rPr lang="en-US" smtClean="0"/>
              <a:t>12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421F25-F1EC-EE47-BE8D-E2D81903C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47FEE4-71A2-EC43-8475-349E602051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B8A27-DF03-4546-BA93-21C967D57E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449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5E8E26-F747-054A-948B-EB5E61091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155CE7-9307-EB44-8AC1-A5D1BD28FC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D9D9C-40DB-3B4A-B570-ECE2A7FB23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98F52-2787-4BA2-BBBC-9395E9F86D50}" type="datetimeFigureOut">
              <a:rPr lang="en-US" smtClean="0"/>
              <a:pPr/>
              <a:t>12-Jun-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683E2-A39A-6041-84EA-E51BC64281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D9304-C9FC-8C41-A14B-09832E009A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B8A27-DF03-4546-BA93-21C967D57E5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554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8" r:id="rId1"/>
    <p:sldLayoutId id="2147483819" r:id="rId2"/>
    <p:sldLayoutId id="2147483820" r:id="rId3"/>
    <p:sldLayoutId id="2147483821" r:id="rId4"/>
    <p:sldLayoutId id="2147483822" r:id="rId5"/>
    <p:sldLayoutId id="2147483823" r:id="rId6"/>
    <p:sldLayoutId id="2147483824" r:id="rId7"/>
    <p:sldLayoutId id="2147483825" r:id="rId8"/>
    <p:sldLayoutId id="2147483826" r:id="rId9"/>
    <p:sldLayoutId id="2147483827" r:id="rId10"/>
    <p:sldLayoutId id="2147483828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DCDC49F-C869-3347-B7B8-022A697EFDC1}"/>
              </a:ext>
            </a:extLst>
          </p:cNvPr>
          <p:cNvSpPr txBox="1"/>
          <p:nvPr/>
        </p:nvSpPr>
        <p:spPr>
          <a:xfrm>
            <a:off x="3410857" y="2322286"/>
            <a:ext cx="552994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Supplementary </a:t>
            </a:r>
            <a:r>
              <a:rPr lang="en-US" sz="2800" dirty="0"/>
              <a:t>Figures: </a:t>
            </a:r>
          </a:p>
          <a:p>
            <a:r>
              <a:rPr lang="en-US" sz="2800" dirty="0"/>
              <a:t>Uploaded in response to Reviewer comments </a:t>
            </a:r>
          </a:p>
        </p:txBody>
      </p:sp>
    </p:spTree>
    <p:extLst>
      <p:ext uri="{BB962C8B-B14F-4D97-AF65-F5344CB8AC3E}">
        <p14:creationId xmlns:p14="http://schemas.microsoft.com/office/powerpoint/2010/main" val="794190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B354C36-7521-8F40-A950-07894AA201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925" y="1871435"/>
            <a:ext cx="3670300" cy="26797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B5D8D33-7C93-E748-B9A8-633D47585D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0883" y="1871435"/>
            <a:ext cx="3754396" cy="26797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40CB966-9B27-114F-AC4D-78923DC9B9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5937" y="1871435"/>
            <a:ext cx="3692453" cy="26797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89559C3-23E1-054D-A346-928B19117E15}"/>
              </a:ext>
            </a:extLst>
          </p:cNvPr>
          <p:cNvSpPr txBox="1"/>
          <p:nvPr/>
        </p:nvSpPr>
        <p:spPr>
          <a:xfrm>
            <a:off x="249925" y="651474"/>
            <a:ext cx="372690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A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verall survival by </a:t>
            </a:r>
            <a:r>
              <a:rPr lang="en-US" sz="1600" u="sng" dirty="0" err="1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rAE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f patients with melanoma</a:t>
            </a:r>
            <a:r>
              <a:rPr lang="en-US" sz="1600" dirty="0">
                <a:effectLst/>
              </a:rPr>
              <a:t> </a:t>
            </a:r>
            <a:endParaRPr lang="en-US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4F13491-FFDC-DC40-9E39-40481E7C7BF2}"/>
              </a:ext>
            </a:extLst>
          </p:cNvPr>
          <p:cNvSpPr txBox="1"/>
          <p:nvPr/>
        </p:nvSpPr>
        <p:spPr>
          <a:xfrm>
            <a:off x="4140883" y="602938"/>
            <a:ext cx="3754396" cy="941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600" u="sng" dirty="0">
                <a:solidFill>
                  <a:srgbClr val="201F1E"/>
                </a:solidFill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B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verall survival by </a:t>
            </a:r>
            <a:r>
              <a:rPr lang="en-US" sz="1600" u="sng" dirty="0" err="1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rAE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f patients with lung cancer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57648A-50F1-A349-B2DE-C8B662F7033E}"/>
              </a:ext>
            </a:extLst>
          </p:cNvPr>
          <p:cNvSpPr txBox="1"/>
          <p:nvPr/>
        </p:nvSpPr>
        <p:spPr>
          <a:xfrm>
            <a:off x="8115937" y="630798"/>
            <a:ext cx="423762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u="sng" dirty="0">
                <a:solidFill>
                  <a:srgbClr val="201F1E"/>
                </a:solidFill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</a:t>
            </a:r>
            <a:r>
              <a:rPr lang="en-US" sz="1600" u="sng" dirty="0" smtClean="0">
                <a:solidFill>
                  <a:srgbClr val="201F1E"/>
                </a:solidFill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600" u="sng" dirty="0">
                <a:solidFill>
                  <a:srgbClr val="201F1E"/>
                </a:solidFill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C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verall survival by </a:t>
            </a:r>
            <a:r>
              <a:rPr lang="en-US" sz="1600" u="sng" dirty="0" err="1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rAE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f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atients with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nal cell carcinoma</a:t>
            </a:r>
            <a:r>
              <a:rPr lang="en-US" sz="1600" dirty="0">
                <a:effectLst/>
              </a:rPr>
              <a:t>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837800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9AB69CE-E3DC-C649-B628-5B5E21CEB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3729" y="1939741"/>
            <a:ext cx="4871358" cy="335812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F2897A0-5971-2240-8657-3EDA34DA20FE}"/>
              </a:ext>
            </a:extLst>
          </p:cNvPr>
          <p:cNvSpPr txBox="1"/>
          <p:nvPr/>
        </p:nvSpPr>
        <p:spPr>
          <a:xfrm>
            <a:off x="3525671" y="505312"/>
            <a:ext cx="4871358" cy="8356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u="none" strike="noStrike" dirty="0">
                <a:solidFill>
                  <a:srgbClr val="242424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u="sng" dirty="0" smtClean="0">
                <a:solidFill>
                  <a:srgbClr val="242424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Supplementary </a:t>
            </a:r>
            <a:r>
              <a:rPr lang="en-US" sz="1400" u="sng" dirty="0">
                <a:solidFill>
                  <a:srgbClr val="242424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Figure </a:t>
            </a:r>
            <a:r>
              <a:rPr lang="en-US" sz="1400" u="sng" dirty="0" smtClean="0">
                <a:solidFill>
                  <a:srgbClr val="242424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1D. </a:t>
            </a:r>
            <a:r>
              <a:rPr lang="en-US" sz="1400" u="sng" dirty="0">
                <a:solidFill>
                  <a:srgbClr val="242424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Post Hospitalization survival by CPI type of patients with melanoma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3330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chart&#10;&#10;Description automatically generated">
            <a:extLst>
              <a:ext uri="{FF2B5EF4-FFF2-40B4-BE49-F238E27FC236}">
                <a16:creationId xmlns:a16="http://schemas.microsoft.com/office/drawing/2014/main" id="{F931A07E-93A1-BC47-968C-3A7717D469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2416" y="1422400"/>
            <a:ext cx="6230371" cy="335642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B77338-33CD-D243-9750-164185A6E437}"/>
              </a:ext>
            </a:extLst>
          </p:cNvPr>
          <p:cNvSpPr txBox="1"/>
          <p:nvPr/>
        </p:nvSpPr>
        <p:spPr>
          <a:xfrm>
            <a:off x="2642416" y="312143"/>
            <a:ext cx="6096000" cy="941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none" strike="noStrike" dirty="0"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2A. </a:t>
            </a:r>
            <a:r>
              <a:rPr lang="en-US" sz="1600" u="sng" dirty="0"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istogram of autoimmune conditions per year of CPI Hospitalization 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94104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D3DDDA-1ED0-6A48-ADED-FC7D0BD37A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841" y="1835593"/>
            <a:ext cx="4563263" cy="331836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59E5C42-932A-0D41-B7D1-D64394FC0B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0558" y="1835594"/>
            <a:ext cx="4381865" cy="318681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D86C82-D7C6-2E40-89E3-9FC41A282C87}"/>
              </a:ext>
            </a:extLst>
          </p:cNvPr>
          <p:cNvSpPr txBox="1"/>
          <p:nvPr/>
        </p:nvSpPr>
        <p:spPr>
          <a:xfrm>
            <a:off x="631209" y="634974"/>
            <a:ext cx="5213779" cy="941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none" strike="noStrike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A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 hospitalization survival by steroid treatment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4B7938-B2B4-E740-B12E-8AA2D1DE13B3}"/>
              </a:ext>
            </a:extLst>
          </p:cNvPr>
          <p:cNvSpPr txBox="1"/>
          <p:nvPr/>
        </p:nvSpPr>
        <p:spPr>
          <a:xfrm>
            <a:off x="6450558" y="885042"/>
            <a:ext cx="5368403" cy="65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B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 hospitalization survival by infliximab treatment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7584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B40791F-1925-5848-A457-D2410ECF63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1785" y="2022807"/>
            <a:ext cx="4068705" cy="295823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E8029E8-AACC-4E4A-8E07-3696F29167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022807"/>
            <a:ext cx="4317242" cy="30732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18B8EA4-BBF2-0543-AF0D-1A19985C309C}"/>
              </a:ext>
            </a:extLst>
          </p:cNvPr>
          <p:cNvSpPr txBox="1"/>
          <p:nvPr/>
        </p:nvSpPr>
        <p:spPr>
          <a:xfrm>
            <a:off x="508380" y="1271921"/>
            <a:ext cx="4601502" cy="65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C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 hospitalization survival by IVIG treatment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B73E9C-3B81-BB4D-9D8A-A7B70D7FAC42}"/>
              </a:ext>
            </a:extLst>
          </p:cNvPr>
          <p:cNvSpPr txBox="1"/>
          <p:nvPr/>
        </p:nvSpPr>
        <p:spPr>
          <a:xfrm>
            <a:off x="6096000" y="1290022"/>
            <a:ext cx="6093724" cy="65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3D.Post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ospitalization survival by </a:t>
            </a:r>
            <a:r>
              <a:rPr lang="en-US" sz="1600" u="sng" dirty="0" err="1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cophenalate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reatment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28885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5FC44AD-3AB2-4B40-9CA1-18F4759291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8625" y="1849267"/>
            <a:ext cx="4891309" cy="338461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7448898-4314-9F42-9926-20577B2130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7351" y="1763696"/>
            <a:ext cx="4891309" cy="35557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1DCF63-C9CE-BF47-B7F5-40D153956A53}"/>
              </a:ext>
            </a:extLst>
          </p:cNvPr>
          <p:cNvSpPr txBox="1"/>
          <p:nvPr/>
        </p:nvSpPr>
        <p:spPr>
          <a:xfrm>
            <a:off x="6338625" y="457554"/>
            <a:ext cx="5480336" cy="941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none" strike="noStrike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err="1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ntary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B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-hospitalization survival by cancer type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D1A01E-AD58-8E4C-BFF1-E5C266CB2644}"/>
              </a:ext>
            </a:extLst>
          </p:cNvPr>
          <p:cNvSpPr txBox="1"/>
          <p:nvPr/>
        </p:nvSpPr>
        <p:spPr>
          <a:xfrm>
            <a:off x="470041" y="743561"/>
            <a:ext cx="5312194" cy="941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A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-hospitalization survival for patients with metastatic vs non-metastatic disease at CPI treatment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36499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18D79F2-C3AB-2846-970B-3A561B93DE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166" y="1545344"/>
            <a:ext cx="5101899" cy="370370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C72E39D-EA48-2148-A81E-69C2E59A14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8935" y="1697644"/>
            <a:ext cx="5101899" cy="35514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3FDB581-0D13-A642-AE0C-C7C42936DBEB}"/>
              </a:ext>
            </a:extLst>
          </p:cNvPr>
          <p:cNvSpPr txBox="1"/>
          <p:nvPr/>
        </p:nvSpPr>
        <p:spPr>
          <a:xfrm>
            <a:off x="6358935" y="844356"/>
            <a:ext cx="6096000" cy="65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D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-hospitalization survival by CPI type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0783CD-8EAE-7043-AFEF-65CCFFB9D93F}"/>
              </a:ext>
            </a:extLst>
          </p:cNvPr>
          <p:cNvSpPr txBox="1"/>
          <p:nvPr/>
        </p:nvSpPr>
        <p:spPr>
          <a:xfrm>
            <a:off x="740391" y="858052"/>
            <a:ext cx="5092674" cy="65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sz="1600" u="sng" dirty="0" smtClean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4C. 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ost-hospitalization survival by </a:t>
            </a:r>
            <a:r>
              <a:rPr lang="en-US" sz="1600" u="sng" dirty="0" err="1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rAE</a:t>
            </a:r>
            <a:r>
              <a:rPr lang="en-US" sz="1600" u="sng" dirty="0">
                <a:solidFill>
                  <a:srgbClr val="201F1E"/>
                </a:solidFill>
                <a:effectLst/>
                <a:latin typeface="Trebuchet MS" panose="020B070302020209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ype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9399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61</TotalTime>
  <Words>160</Words>
  <Application>Microsoft Office PowerPoint</Application>
  <PresentationFormat>Widescreen</PresentationFormat>
  <Paragraphs>1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Segoe UI</vt:lpstr>
      <vt:lpstr>Times New Roman</vt:lpstr>
      <vt:lpstr>Trebuchet M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im 1: Identify risk factors for hospitalization for immune related adverse events from cancer immunotherapies</dc:title>
  <dc:creator>Jordyn Silverstein</dc:creator>
  <cp:lastModifiedBy>Priyanka M</cp:lastModifiedBy>
  <cp:revision>52</cp:revision>
  <dcterms:created xsi:type="dcterms:W3CDTF">2022-05-13T22:11:58Z</dcterms:created>
  <dcterms:modified xsi:type="dcterms:W3CDTF">2023-06-12T06:41:15Z</dcterms:modified>
</cp:coreProperties>
</file>